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2D1000EE-8DC9-47BD-82F8-F55E651AFB5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B44AB82-02CF-4E43-A1FE-7E6A6B7477A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D905BE0-E045-49A3-87ED-91CEC3C69A0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24589F8-D899-45B3-82D3-5566B39B106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BE8005C-15E7-4FFE-9944-7140F578230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1114EC2-95F2-4781-B25E-E14E53D829F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F8BF19C-0C6D-4B50-89C1-FEDBBDD53F0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215D13A-56CF-4AF8-9DD0-EA9865F7C74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ADE9654-7F14-4807-9CD1-99B3484059C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327FA46-215E-42AA-8FC1-A01E07A2709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EF2B8D2-847D-4A49-98F6-81AE5F0E551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E30327C-D888-45E6-9E97-06B23A57E4E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74051E0-8E3C-4341-B6FC-470E98BD6A19}"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
          <p:cNvSpPr/>
          <p:nvPr/>
        </p:nvSpPr>
        <p:spPr>
          <a:xfrm>
            <a:off x="914400" y="6443640"/>
            <a:ext cx="7924680" cy="3373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Additional Figure 3  </a:t>
            </a:r>
            <a:r>
              <a:rPr b="0" lang="en-US" sz="800" spc="-1" strike="noStrike">
                <a:solidFill>
                  <a:srgbClr val="000000"/>
                </a:solidFill>
                <a:latin typeface="Arial"/>
                <a:ea typeface="Arial"/>
              </a:rPr>
              <a:t>- Copy number variation plot summary of 18 oral tongue squamous cell carcinoma patients in the discovery set. The samples are sorted according to smokers and never smokers as indicated. Regions of gains and losses are color coded as per the legend. </a:t>
            </a:r>
            <a:endParaRPr b="0" lang="en-US" sz="800" spc="-1" strike="noStrike">
              <a:solidFill>
                <a:srgbClr val="000000"/>
              </a:solidFill>
              <a:latin typeface="Calibri"/>
            </a:endParaRPr>
          </a:p>
        </p:txBody>
      </p:sp>
      <p:sp>
        <p:nvSpPr>
          <p:cNvPr id="42" name="TextBox 1"/>
          <p:cNvSpPr/>
          <p:nvPr/>
        </p:nvSpPr>
        <p:spPr>
          <a:xfrm>
            <a:off x="86760" y="76320"/>
            <a:ext cx="10522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Additional Figure 3</a:t>
            </a:r>
            <a:endParaRPr b="0" lang="en-US" sz="900" spc="-1" strike="noStrike">
              <a:solidFill>
                <a:srgbClr val="000000"/>
              </a:solidFill>
              <a:latin typeface="Calibri"/>
            </a:endParaRPr>
          </a:p>
        </p:txBody>
      </p:sp>
      <p:grpSp>
        <p:nvGrpSpPr>
          <p:cNvPr id="43" name="Group 4"/>
          <p:cNvGrpSpPr/>
          <p:nvPr/>
        </p:nvGrpSpPr>
        <p:grpSpPr>
          <a:xfrm>
            <a:off x="304920" y="306360"/>
            <a:ext cx="8758080" cy="5810400"/>
            <a:chOff x="304920" y="306360"/>
            <a:chExt cx="8758080" cy="5810400"/>
          </a:xfrm>
        </p:grpSpPr>
        <p:pic>
          <p:nvPicPr>
            <p:cNvPr id="44" name="Picture 55" descr=""/>
            <p:cNvPicPr/>
            <p:nvPr/>
          </p:nvPicPr>
          <p:blipFill>
            <a:blip r:embed="rId1"/>
            <a:srcRect l="0" t="6655" r="0" b="1207"/>
            <a:stretch/>
          </p:blipFill>
          <p:spPr>
            <a:xfrm>
              <a:off x="304920" y="306360"/>
              <a:ext cx="8758080" cy="5810400"/>
            </a:xfrm>
            <a:prstGeom prst="rect">
              <a:avLst/>
            </a:prstGeom>
            <a:ln w="0">
              <a:noFill/>
            </a:ln>
          </p:spPr>
        </p:pic>
        <p:sp>
          <p:nvSpPr>
            <p:cNvPr id="45" name="Rectangle 3"/>
            <p:cNvSpPr/>
            <p:nvPr/>
          </p:nvSpPr>
          <p:spPr>
            <a:xfrm>
              <a:off x="304920" y="2895480"/>
              <a:ext cx="152280" cy="60948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sp>
        <p:nvSpPr>
          <p:cNvPr id="46" name="Right Brace 2"/>
          <p:cNvSpPr/>
          <p:nvPr/>
        </p:nvSpPr>
        <p:spPr>
          <a:xfrm flipH="1">
            <a:off x="361800" y="762120"/>
            <a:ext cx="76320" cy="1904760"/>
          </a:xfrm>
          <a:custGeom>
            <a:avLst/>
            <a:gdLst>
              <a:gd name="textAreaLeft" fmla="*/ 0 w 76320"/>
              <a:gd name="textAreaRight" fmla="*/ 27360 w 76320"/>
              <a:gd name="textAreaTop" fmla="*/ 1800 h 1904760"/>
              <a:gd name="textAreaBottom" fmla="*/ 1902960 h 1904760"/>
            </a:gdLst>
            <a:ahLst/>
            <a:rect l="textAreaLeft" t="textAreaTop" r="textAreaRight" b="textAreaBottom"/>
            <a:pathLst>
              <a:path w="21600" h="21600">
                <a:moveTo>
                  <a:pt x="0" y="0"/>
                </a:moveTo>
                <a:cubicBezTo>
                  <a:pt x="5400" y="0"/>
                  <a:pt x="10800" y="36"/>
                  <a:pt x="10800" y="72"/>
                </a:cubicBezTo>
                <a:lnTo>
                  <a:pt x="10800" y="10728"/>
                </a:lnTo>
                <a:cubicBezTo>
                  <a:pt x="10800" y="10764"/>
                  <a:pt x="16200" y="10800"/>
                  <a:pt x="21600" y="10800"/>
                </a:cubicBezTo>
                <a:cubicBezTo>
                  <a:pt x="16200" y="10800"/>
                  <a:pt x="10800" y="10836"/>
                  <a:pt x="10800" y="10872"/>
                </a:cubicBezTo>
                <a:lnTo>
                  <a:pt x="10800" y="21528"/>
                </a:lnTo>
                <a:cubicBezTo>
                  <a:pt x="10800" y="21564"/>
                  <a:pt x="5400" y="21600"/>
                  <a:pt x="0" y="21600"/>
                </a:cubicBezTo>
              </a:path>
            </a:pathLst>
          </a:custGeom>
          <a:noFill/>
          <a:ln w="1908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Right Brace 57"/>
          <p:cNvSpPr/>
          <p:nvPr/>
        </p:nvSpPr>
        <p:spPr>
          <a:xfrm flipH="1">
            <a:off x="390600" y="2819520"/>
            <a:ext cx="47520" cy="2819160"/>
          </a:xfrm>
          <a:custGeom>
            <a:avLst/>
            <a:gdLst>
              <a:gd name="textAreaLeft" fmla="*/ 0 w 47520"/>
              <a:gd name="textAreaRight" fmla="*/ 17280 w 47520"/>
              <a:gd name="textAreaTop" fmla="*/ 1080 h 2819160"/>
              <a:gd name="textAreaBottom" fmla="*/ 2818080 h 2819160"/>
            </a:gdLst>
            <a:ahLst/>
            <a:rect l="textAreaLeft" t="textAreaTop" r="textAreaRight" b="textAreaBottom"/>
            <a:pathLst>
              <a:path w="21600" h="21600">
                <a:moveTo>
                  <a:pt x="0" y="0"/>
                </a:moveTo>
                <a:cubicBezTo>
                  <a:pt x="5400" y="0"/>
                  <a:pt x="10800" y="15"/>
                  <a:pt x="10800" y="30"/>
                </a:cubicBezTo>
                <a:lnTo>
                  <a:pt x="10800" y="10770"/>
                </a:lnTo>
                <a:cubicBezTo>
                  <a:pt x="10800" y="10785"/>
                  <a:pt x="16200" y="10800"/>
                  <a:pt x="21600" y="10800"/>
                </a:cubicBezTo>
                <a:cubicBezTo>
                  <a:pt x="16200" y="10800"/>
                  <a:pt x="10800" y="10815"/>
                  <a:pt x="10800" y="10830"/>
                </a:cubicBezTo>
                <a:lnTo>
                  <a:pt x="10800" y="21570"/>
                </a:lnTo>
                <a:cubicBezTo>
                  <a:pt x="10800" y="21585"/>
                  <a:pt x="5400" y="21600"/>
                  <a:pt x="0" y="21600"/>
                </a:cubicBezTo>
              </a:path>
            </a:pathLst>
          </a:custGeom>
          <a:noFill/>
          <a:ln w="1908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8" name="TextBox 5"/>
          <p:cNvSpPr/>
          <p:nvPr/>
        </p:nvSpPr>
        <p:spPr>
          <a:xfrm rot="16200000">
            <a:off x="-292680" y="1504800"/>
            <a:ext cx="976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0000"/>
                </a:solidFill>
                <a:latin typeface="Calibri"/>
              </a:rPr>
              <a:t>Smokers</a:t>
            </a:r>
            <a:endParaRPr b="0" lang="en-US" sz="1800" spc="-1" strike="noStrike">
              <a:solidFill>
                <a:srgbClr val="000000"/>
              </a:solidFill>
              <a:latin typeface="Calibri"/>
            </a:endParaRPr>
          </a:p>
        </p:txBody>
      </p:sp>
      <p:sp>
        <p:nvSpPr>
          <p:cNvPr id="49" name="TextBox 61"/>
          <p:cNvSpPr/>
          <p:nvPr/>
        </p:nvSpPr>
        <p:spPr>
          <a:xfrm rot="16200000">
            <a:off x="-599760" y="3997080"/>
            <a:ext cx="15904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0000"/>
                </a:solidFill>
                <a:latin typeface="Calibri"/>
              </a:rPr>
              <a:t>Never-smokers</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33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8-20T15:03:52Z</dcterms:created>
  <dc:creator>HP</dc:creator>
  <dc:description/>
  <dc:language>en-US</dc:language>
  <cp:lastModifiedBy>N.Gopalakrishna Iyer</cp:lastModifiedBy>
  <dcterms:modified xsi:type="dcterms:W3CDTF">2015-07-15T02:48:41Z</dcterms:modified>
  <cp:revision>39</cp:revision>
  <dc:subject/>
  <dc:title>Apresentação do PowerPoint</dc:title>
</cp:coreProperties>
</file>